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 varScale="1">
        <p:scale>
          <a:sx n="97" d="100"/>
          <a:sy n="97" d="100"/>
        </p:scale>
        <p:origin x="1110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7ECEFAC-A913-4C3C-03F4-B02004E6C6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16581602-3C57-48A2-30E7-42A9DBACE4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03BBBEB-0250-DEC6-7BDA-F80F1BB9EC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786B-8A04-495A-95F6-DC431E98FE9C}" type="datetimeFigureOut">
              <a:rPr lang="pt-BR" smtClean="0"/>
              <a:t>15/1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A91E98D3-B6A1-AC1F-6488-D1A664BE0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0F46CFA-BC01-C3CA-3ADE-E3D85ED296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304F6-4AE7-462C-9B04-38274A035A3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83282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AEA445F-DC03-0CF6-1648-588CEDAB08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7C5199EC-1CF8-EFF8-5211-CAB37BD9D8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ADFC722-F890-285F-BF24-9BC3B88ECB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786B-8A04-495A-95F6-DC431E98FE9C}" type="datetimeFigureOut">
              <a:rPr lang="pt-BR" smtClean="0"/>
              <a:t>15/1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93B7E42-45E0-8476-025C-18693C5E3D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B3391A2A-2202-1616-D5D7-8BBFBA643D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304F6-4AE7-462C-9B04-38274A035A3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81395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500C9DD-F501-1D63-84A3-DC758AB65AB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C36C5163-D5ED-451B-C739-E3813A3470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A5E4276F-FF18-BEB2-3AE7-E9D10B21B2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786B-8A04-495A-95F6-DC431E98FE9C}" type="datetimeFigureOut">
              <a:rPr lang="pt-BR" smtClean="0"/>
              <a:t>15/1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609C486E-0661-44AA-04BD-F27CF4152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8C5C16A-E14D-7033-6003-2AF2586FD5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304F6-4AE7-462C-9B04-38274A035A3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47857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650FFC3-C350-E4B5-13D3-9015262CB4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68A0298C-AEB1-E212-1EE5-B82574389A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780303D-98B5-2953-0397-4B714C579C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786B-8A04-495A-95F6-DC431E98FE9C}" type="datetimeFigureOut">
              <a:rPr lang="pt-BR" smtClean="0"/>
              <a:t>15/1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071F027F-7D10-590E-2F28-D931F945E3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34FAAA45-B8C2-0348-B003-59B50344AE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304F6-4AE7-462C-9B04-38274A035A3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48919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89DBAAC-5624-FA4C-5323-E7CA2FF879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32715239-8265-7ACB-D8FA-5D803F54DA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9CBF2337-4E06-3212-816B-E1289985A7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786B-8A04-495A-95F6-DC431E98FE9C}" type="datetimeFigureOut">
              <a:rPr lang="pt-BR" smtClean="0"/>
              <a:t>15/1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836CD4EC-A89E-81AF-B3E0-1C9E4AA0D5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94902A5-6A68-EFA3-2B8C-928FDF135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304F6-4AE7-462C-9B04-38274A035A3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721820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09E6312-8BC4-1ACB-46BA-4421E6F4E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EC4F8EDB-4F98-9A02-7889-E99A075FFB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4015A4D6-700E-63B1-44BF-58C7CD1485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F4A5E346-9E1B-F2D3-D1C2-22C1C9F2FE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786B-8A04-495A-95F6-DC431E98FE9C}" type="datetimeFigureOut">
              <a:rPr lang="pt-BR" smtClean="0"/>
              <a:t>15/12/2025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3D2E1EFA-874C-67D7-38B3-ADE5B0D53D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90FF91F0-7710-9A09-6CFF-DB64EB811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304F6-4AE7-462C-9B04-38274A035A3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874630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1BDB3EB-751E-3F6A-8FAB-0EECCFA608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76D3C89C-89C7-328E-C8A7-6FE7BEF404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3688313E-BE7C-3C1D-FC70-3585A19BAE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7A9AAF27-2A4D-3259-7256-F4E5052D004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62C3F3DB-88F4-BEBD-63FD-25CB6481B6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877A3062-0774-E50F-C84C-7D1058B3A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786B-8A04-495A-95F6-DC431E98FE9C}" type="datetimeFigureOut">
              <a:rPr lang="pt-BR" smtClean="0"/>
              <a:t>15/12/2025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BE9A249F-7A14-F739-8111-698795C486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657742E9-E149-199B-640F-95F66FE3C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304F6-4AE7-462C-9B04-38274A035A3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6647720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AD46774-7693-E2FB-D231-0C3C371287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A2C0B3CB-BB7D-B57E-19D9-400E3D03AA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786B-8A04-495A-95F6-DC431E98FE9C}" type="datetimeFigureOut">
              <a:rPr lang="pt-BR" smtClean="0"/>
              <a:t>15/12/2025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4233040B-621E-19CC-5109-3BA711B854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15DA1785-E24E-91FE-5B7A-8093FB8C7C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304F6-4AE7-462C-9B04-38274A035A3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85031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F99F547E-6346-649A-D118-581D74AC8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786B-8A04-495A-95F6-DC431E98FE9C}" type="datetimeFigureOut">
              <a:rPr lang="pt-BR" smtClean="0"/>
              <a:t>15/12/2025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BD459B99-2019-5967-5A14-BFD3EAF4C5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94A13B53-AF67-6F41-6FDA-546B9C634B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304F6-4AE7-462C-9B04-38274A035A3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727719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53AF8AC-7295-B071-2281-CEBD45D36B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475DA5E5-FFB0-EFE6-7CE8-0A6620E2BB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23E875BE-95F9-5846-AE86-362ABCC9EE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8EEFBFF9-04F5-6A2C-E3FE-5A3547EA2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786B-8A04-495A-95F6-DC431E98FE9C}" type="datetimeFigureOut">
              <a:rPr lang="pt-BR" smtClean="0"/>
              <a:t>15/12/2025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975D15CA-2621-EE4A-DA1B-E3E43889C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F354FA2F-03B4-5A44-0879-7D4F5323AD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304F6-4AE7-462C-9B04-38274A035A3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984616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7C07F51-8B6F-BFE2-C55C-7545A3EF08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19A9A992-88B3-A3EE-B75D-36EA1559D6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E35AF389-50A5-999F-1C41-EA5D94BA95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3C7065A3-9860-32BF-8CC7-551399C54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6B786B-8A04-495A-95F6-DC431E98FE9C}" type="datetimeFigureOut">
              <a:rPr lang="pt-BR" smtClean="0"/>
              <a:t>15/12/2025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A205F083-DFC4-45AF-4ECA-2DEDC8527E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9B72628E-50FF-9966-55DF-21D19801E0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1304F6-4AE7-462C-9B04-38274A035A3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34191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B08614D9-7E74-3374-5296-A43D171C72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903686F3-EE2A-58C0-A217-9ADDED37BF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7C1E349F-AFDA-D2E4-B861-119E96BE06D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C6B786B-8A04-495A-95F6-DC431E98FE9C}" type="datetimeFigureOut">
              <a:rPr lang="pt-BR" smtClean="0"/>
              <a:t>15/1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C317BCF8-7DEC-231F-065E-C850C7E134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3262B137-2F90-B6C3-3108-C57EA0239C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61304F6-4AE7-462C-9B04-38274A035A3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780685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agem 11">
            <a:extLst>
              <a:ext uri="{FF2B5EF4-FFF2-40B4-BE49-F238E27FC236}">
                <a16:creationId xmlns:a16="http://schemas.microsoft.com/office/drawing/2014/main" id="{14F207AE-9191-E925-9683-7090B2B0BFF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8607" t="14850" r="29549" b="7537"/>
          <a:stretch>
            <a:fillRect/>
          </a:stretch>
        </p:blipFill>
        <p:spPr>
          <a:xfrm>
            <a:off x="2487879" y="717755"/>
            <a:ext cx="7540054" cy="4364669"/>
          </a:xfrm>
          <a:prstGeom prst="rect">
            <a:avLst/>
          </a:prstGeom>
        </p:spPr>
      </p:pic>
      <p:sp>
        <p:nvSpPr>
          <p:cNvPr id="13" name="Chave Esquerda 12">
            <a:extLst>
              <a:ext uri="{FF2B5EF4-FFF2-40B4-BE49-F238E27FC236}">
                <a16:creationId xmlns:a16="http://schemas.microsoft.com/office/drawing/2014/main" id="{B1AAF38D-1FF5-7788-78D4-50BF8B080ACC}"/>
              </a:ext>
            </a:extLst>
          </p:cNvPr>
          <p:cNvSpPr/>
          <p:nvPr/>
        </p:nvSpPr>
        <p:spPr>
          <a:xfrm rot="16200000">
            <a:off x="5139449" y="3659555"/>
            <a:ext cx="178006" cy="2921798"/>
          </a:xfrm>
          <a:prstGeom prst="leftBrace">
            <a:avLst>
              <a:gd name="adj1" fmla="val 107452"/>
              <a:gd name="adj2" fmla="val 52685"/>
            </a:avLst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4" name="Chave Esquerda 13">
            <a:extLst>
              <a:ext uri="{FF2B5EF4-FFF2-40B4-BE49-F238E27FC236}">
                <a16:creationId xmlns:a16="http://schemas.microsoft.com/office/drawing/2014/main" id="{4DCB9B64-7486-0975-3984-51BEBBCB73BC}"/>
              </a:ext>
            </a:extLst>
          </p:cNvPr>
          <p:cNvSpPr/>
          <p:nvPr/>
        </p:nvSpPr>
        <p:spPr>
          <a:xfrm rot="16200000">
            <a:off x="8143709" y="3659555"/>
            <a:ext cx="178007" cy="2921796"/>
          </a:xfrm>
          <a:prstGeom prst="leftBrace">
            <a:avLst>
              <a:gd name="adj1" fmla="val 107452"/>
              <a:gd name="adj2" fmla="val 52685"/>
            </a:avLst>
          </a:prstGeom>
          <a:ln w="2857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pt-BR"/>
          </a:p>
        </p:txBody>
      </p: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ED109B97-FB82-4953-4BB2-F44B28B00DE1}"/>
              </a:ext>
            </a:extLst>
          </p:cNvPr>
          <p:cNvSpPr txBox="1"/>
          <p:nvPr/>
        </p:nvSpPr>
        <p:spPr>
          <a:xfrm>
            <a:off x="6903476" y="5209457"/>
            <a:ext cx="295729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b="1" dirty="0"/>
              <a:t>RNA </a:t>
            </a:r>
            <a:r>
              <a:rPr lang="pt-BR" b="1" dirty="0" err="1"/>
              <a:t>to</a:t>
            </a:r>
            <a:r>
              <a:rPr lang="pt-BR" b="1" dirty="0"/>
              <a:t> non-</a:t>
            </a:r>
            <a:r>
              <a:rPr lang="pt-BR" b="1" dirty="0" err="1"/>
              <a:t>infected</a:t>
            </a:r>
            <a:r>
              <a:rPr lang="pt-BR" b="1" dirty="0"/>
              <a:t> </a:t>
            </a:r>
            <a:r>
              <a:rPr lang="pt-BR" b="1" dirty="0" err="1"/>
              <a:t>animals</a:t>
            </a:r>
            <a:endParaRPr lang="pt-BR" b="1" dirty="0"/>
          </a:p>
        </p:txBody>
      </p:sp>
      <p:sp>
        <p:nvSpPr>
          <p:cNvPr id="16" name="CaixaDeTexto 15">
            <a:extLst>
              <a:ext uri="{FF2B5EF4-FFF2-40B4-BE49-F238E27FC236}">
                <a16:creationId xmlns:a16="http://schemas.microsoft.com/office/drawing/2014/main" id="{ABDDFBB2-E110-1219-71A5-F2472A2C8E96}"/>
              </a:ext>
            </a:extLst>
          </p:cNvPr>
          <p:cNvSpPr txBox="1"/>
          <p:nvPr/>
        </p:nvSpPr>
        <p:spPr>
          <a:xfrm>
            <a:off x="3908480" y="5271333"/>
            <a:ext cx="24655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b="1" dirty="0"/>
              <a:t>RNA </a:t>
            </a:r>
            <a:r>
              <a:rPr lang="pt-BR" b="1" dirty="0" err="1"/>
              <a:t>to</a:t>
            </a:r>
            <a:r>
              <a:rPr lang="pt-BR" b="1" dirty="0"/>
              <a:t> </a:t>
            </a:r>
            <a:r>
              <a:rPr lang="pt-BR" b="1" dirty="0" err="1"/>
              <a:t>infected</a:t>
            </a:r>
            <a:r>
              <a:rPr lang="pt-BR" b="1" dirty="0"/>
              <a:t> </a:t>
            </a:r>
            <a:r>
              <a:rPr lang="pt-BR" b="1" dirty="0" err="1"/>
              <a:t>animals</a:t>
            </a:r>
            <a:endParaRPr lang="pt-BR" b="1" dirty="0"/>
          </a:p>
        </p:txBody>
      </p:sp>
      <p:sp>
        <p:nvSpPr>
          <p:cNvPr id="3" name="CaixaDeTexto 2">
            <a:extLst>
              <a:ext uri="{FF2B5EF4-FFF2-40B4-BE49-F238E27FC236}">
                <a16:creationId xmlns:a16="http://schemas.microsoft.com/office/drawing/2014/main" id="{32B50100-BCA1-A691-F964-4646D31BB61F}"/>
              </a:ext>
            </a:extLst>
          </p:cNvPr>
          <p:cNvSpPr txBox="1"/>
          <p:nvPr/>
        </p:nvSpPr>
        <p:spPr>
          <a:xfrm>
            <a:off x="3209906" y="5982821"/>
            <a:ext cx="6096000" cy="13684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  <a:buNone/>
            </a:pPr>
            <a:r>
              <a:rPr lang="pt-BR" sz="1800" b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Supplementary</a:t>
            </a:r>
            <a:r>
              <a:rPr lang="pt-B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 Fig. 6: </a:t>
            </a:r>
            <a:r>
              <a:rPr lang="pt-BR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Result</a:t>
            </a:r>
            <a:r>
              <a:rPr lang="pt-B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pt-BR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of</a:t>
            </a:r>
            <a:r>
              <a:rPr lang="pt-B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pt-BR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the</a:t>
            </a:r>
            <a:r>
              <a:rPr lang="pt-B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pt-BR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extraction</a:t>
            </a:r>
            <a:r>
              <a:rPr lang="pt-B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pt-BR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of</a:t>
            </a:r>
            <a:r>
              <a:rPr lang="pt-B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 RNA </a:t>
            </a:r>
            <a:r>
              <a:rPr lang="pt-BR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from</a:t>
            </a:r>
            <a:r>
              <a:rPr lang="pt-B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pt-BR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the</a:t>
            </a:r>
            <a:r>
              <a:rPr lang="pt-B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pt-BR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liver</a:t>
            </a:r>
            <a:r>
              <a:rPr lang="pt-B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pt-BR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of</a:t>
            </a:r>
            <a:r>
              <a:rPr lang="pt-B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pt-BR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uninfected</a:t>
            </a:r>
            <a:r>
              <a:rPr lang="pt-B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pt-BR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animals</a:t>
            </a:r>
            <a:r>
              <a:rPr lang="pt-B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 (CTRL) </a:t>
            </a:r>
            <a:r>
              <a:rPr lang="pt-BR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and</a:t>
            </a:r>
            <a:r>
              <a:rPr lang="pt-B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pt-BR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infected</a:t>
            </a:r>
            <a:r>
              <a:rPr lang="pt-BR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pt-BR" sz="18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at</a:t>
            </a:r>
            <a:r>
              <a:rPr lang="pt-B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 </a:t>
            </a:r>
            <a:r>
              <a:rPr lang="pt-B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7 </a:t>
            </a:r>
            <a:r>
              <a:rPr lang="pt-BR" sz="18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wpi</a:t>
            </a:r>
            <a:r>
              <a:rPr lang="pt-BR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.</a:t>
            </a:r>
            <a:endParaRPr lang="pt-BR" sz="2400" dirty="0">
              <a:effectLst/>
              <a:latin typeface="Aptos" panose="020B0004020202020204" pitchFamily="34" charset="0"/>
              <a:ea typeface="Aptos" panose="020B0004020202020204" pitchFamily="34" charset="0"/>
              <a:cs typeface="Aptos" panose="020B0004020202020204" pitchFamily="34" charset="0"/>
            </a:endParaRPr>
          </a:p>
          <a:p>
            <a:pPr indent="449580" algn="just">
              <a:lnSpc>
                <a:spcPct val="150000"/>
              </a:lnSpc>
              <a:spcAft>
                <a:spcPts val="800"/>
              </a:spcAft>
              <a:buNone/>
            </a:pPr>
            <a:r>
              <a:rPr lang="pt-BR" sz="2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ptos" panose="020B0004020202020204" pitchFamily="34" charset="0"/>
              </a:rPr>
              <a:t> </a:t>
            </a:r>
            <a:endParaRPr lang="pt-BR" sz="2400" dirty="0">
              <a:effectLst/>
              <a:latin typeface="Aptos" panose="020B0004020202020204" pitchFamily="34" charset="0"/>
              <a:ea typeface="Aptos" panose="020B0004020202020204" pitchFamily="34" charset="0"/>
              <a:cs typeface="Aptos" panose="020B00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477571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5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OBSON CORREA</dc:creator>
  <cp:lastModifiedBy>Fernanda Cabral</cp:lastModifiedBy>
  <cp:revision>2</cp:revision>
  <dcterms:created xsi:type="dcterms:W3CDTF">2025-11-06T19:26:28Z</dcterms:created>
  <dcterms:modified xsi:type="dcterms:W3CDTF">2025-12-15T20:19:45Z</dcterms:modified>
</cp:coreProperties>
</file>